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751" autoAdjust="0"/>
    <p:restoredTop sz="94660"/>
  </p:normalViewPr>
  <p:slideViewPr>
    <p:cSldViewPr snapToGrid="0">
      <p:cViewPr varScale="1">
        <p:scale>
          <a:sx n="60" d="100"/>
          <a:sy n="60" d="100"/>
        </p:scale>
        <p:origin x="2256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0AC67F4-EC0C-B85E-EE89-8A606B8816C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92F7FDE-1BF1-3C32-6D71-2AEAED5B4EF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0EE22CB-7F6C-FB6B-9A21-3C015CFB4F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518D23D-5094-97A7-7B3F-5401DFAAC1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19CE3AD-E20A-9FBD-229F-BEBED8E077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30952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FC1D3CF-C684-57BD-93AE-6B5C8A3A84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5C510A5-23D0-68A1-AB26-3B53D4D7C9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ADB9D42-E037-EEDD-E39E-C6BB601359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9E2C8FA-6187-33C8-FE83-B508E79814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61BD825-941E-4E74-D29A-A84BB5C70C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9434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79437FC-5655-D011-D345-E16273DBD37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0C33DF9-63D6-3439-42E3-FF944BCC33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7D5B432-90B3-A8E3-2608-0A948DAA39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142BA72-CFE3-5D78-F96B-A404841390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0EBF169-0E81-453E-8CD1-E507CA60B1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91749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BD78601-0F8B-68C8-22CA-F2F65F4FC8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319478E-632D-5349-7679-A76C39E22D2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33A388C-DC1E-B5A6-CFE7-F564D2EC91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96B3A87-DD68-C5F7-67C5-970AE44E18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A17315B-DE62-6836-6934-BBF78FBD87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40599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F991AB7-301F-E5DC-C0B4-241A31E505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99588C3-DBC7-9B1D-EAF6-FCD2D86A36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E3F6DC4-2474-9D76-CF0D-E349F73BD3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A0620F7-344B-739B-DAC3-0E8C3B7C8E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123655B-A33D-15E8-B5BF-7A70783F31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32273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EAAF682-45AA-14ED-4C46-A4B3DA5AE0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B0A27E4-BC88-280A-7A4D-0C726F23DCD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1A11CFA-5956-4DD3-03F7-0DB1EE8CAF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6CFA3EB-ACAC-BB4E-3064-34D5407BC5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E1E250D-E14F-4E37-494A-8CF83D20EE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2D66EC3-50FF-8B7B-4FD8-1C9A311FBE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8583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F142A5A-1335-0482-4552-02FE9EA95B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57A4954-720B-B7F2-49EA-7DBB6E8102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F5F3D1E-E112-4845-1A8F-D105655F92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AE89D75-375E-635C-7C20-D30D582F11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2F6112E-70A8-5B3A-0147-E3D0F28F3BC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66FDC1D-5448-FFDD-9161-B60AB5FC5A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188A933-ED47-9339-167E-CCB4ADB938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D8D146D-7AD3-6E39-CC72-EA041FFC46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162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F9A70BD-D00C-F4F4-D566-58F87928A5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2F718D0F-882B-5CB3-4392-7279901E0F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10E251E-7A6B-F4D3-8E5A-D5E9304022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CDCBA11-83C4-CB64-2B90-A58D6BC663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42752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E4EBCB2-266C-DC7F-A4EB-DED76D9E0B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63EA25B-4D4A-B753-89EB-D22B50A82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420C7E3-30DA-94EB-8B28-4F483CDF6C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24006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E4F3878-8586-876C-6537-3ABFB71F48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E8E0335-C01C-993A-7F9E-32568BE075B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7A474A7-9920-D957-A496-5015091AC6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BCBC53E-B774-1BDE-8253-889F0CEA12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9120EAD-69F5-27F7-A570-D35F0B5682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CE42338-CDC7-F4FF-463A-6B8A900F1A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65941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4179C6A-CCB2-4A41-D99F-0D00D3A3F2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2CD2BDA-B69D-D060-DE07-8E2AB2B4D92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D357D4B-BA80-EEAC-82B0-ED1FFCA077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D9140CE-0613-13BF-8125-1F6620DE29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5B5976A-6856-A534-FECC-C4F479059D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E364758-8E25-30F1-3A46-1A093597B8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15850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7FE269C-C21F-ED7F-26CD-813D838321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B83E3F3-501C-3DDB-5FD2-E5AA00BB94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0A9C21C-1AF7-9775-BCED-584876F156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A10A8FA-16BF-BFD1-0361-AB039EA45ED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2F21A64-6499-D383-F7E2-B222B691796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31978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kumimoji="1"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kumimoji="1"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821F980-6B33-4B63-BE56-4E29688B29B4}"/>
              </a:ext>
            </a:extLst>
          </p:cNvPr>
          <p:cNvSpPr txBox="1"/>
          <p:nvPr/>
        </p:nvSpPr>
        <p:spPr>
          <a:xfrm>
            <a:off x="197224" y="152400"/>
            <a:ext cx="64258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Fig. S5</a:t>
            </a:r>
            <a:endParaRPr kumimoji="1" lang="ja-JP" altLang="en-US" sz="1400" i="1" dirty="0"/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367BFA8A-3678-4EEA-970B-7ABBDD20AD0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478280" y="1115142"/>
            <a:ext cx="3901440" cy="2926080"/>
          </a:xfrm>
          <a:prstGeom prst="rect">
            <a:avLst/>
          </a:prstGeom>
        </p:spPr>
      </p:pic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743AAC2B-C3E3-49A2-A791-8F9998DCD6AF}"/>
              </a:ext>
            </a:extLst>
          </p:cNvPr>
          <p:cNvCxnSpPr/>
          <p:nvPr/>
        </p:nvCxnSpPr>
        <p:spPr>
          <a:xfrm>
            <a:off x="4669496" y="3913848"/>
            <a:ext cx="576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BFD8A3A-C1D6-4D7A-8353-3F342FB88E16}"/>
              </a:ext>
            </a:extLst>
          </p:cNvPr>
          <p:cNvSpPr txBox="1"/>
          <p:nvPr/>
        </p:nvSpPr>
        <p:spPr>
          <a:xfrm>
            <a:off x="4714162" y="3654458"/>
            <a:ext cx="714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100</a:t>
            </a:r>
            <a:endParaRPr kumimoji="1" lang="ja-JP" altLang="en-US" sz="1200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620ECB1-D16D-47A2-B0D2-2A09073BB635}"/>
              </a:ext>
            </a:extLst>
          </p:cNvPr>
          <p:cNvSpPr txBox="1"/>
          <p:nvPr/>
        </p:nvSpPr>
        <p:spPr>
          <a:xfrm>
            <a:off x="4991472" y="1118389"/>
            <a:ext cx="3882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#1</a:t>
            </a:r>
            <a:endParaRPr kumimoji="1" lang="ja-JP" altLang="en-US" sz="1400" dirty="0"/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78B86DA9-4239-4913-AADB-A32D21234EA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78280" y="4095093"/>
            <a:ext cx="3901440" cy="2926080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7F48DA8-0980-4A5F-9E66-C76E00CCDB60}"/>
              </a:ext>
            </a:extLst>
          </p:cNvPr>
          <p:cNvSpPr txBox="1"/>
          <p:nvPr/>
        </p:nvSpPr>
        <p:spPr>
          <a:xfrm>
            <a:off x="4991472" y="4095367"/>
            <a:ext cx="3882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#3</a:t>
            </a:r>
            <a:endParaRPr kumimoji="1" lang="ja-JP" altLang="en-US" sz="1400" dirty="0"/>
          </a:p>
        </p:txBody>
      </p: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73E20FCD-37F5-4F27-BE51-42183482A952}"/>
              </a:ext>
            </a:extLst>
          </p:cNvPr>
          <p:cNvCxnSpPr/>
          <p:nvPr/>
        </p:nvCxnSpPr>
        <p:spPr>
          <a:xfrm>
            <a:off x="4683972" y="6878360"/>
            <a:ext cx="576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A18EEFD9-8A6E-3DC2-24A8-749B39C0B1AD}"/>
              </a:ext>
            </a:extLst>
          </p:cNvPr>
          <p:cNvSpPr txBox="1"/>
          <p:nvPr/>
        </p:nvSpPr>
        <p:spPr>
          <a:xfrm>
            <a:off x="1272540" y="7515696"/>
            <a:ext cx="431292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/>
              <a:t>Fig. S5 The lamellar OE of </a:t>
            </a:r>
            <a:r>
              <a:rPr lang="en-US" altLang="ja-JP" sz="1200" i="1" dirty="0"/>
              <a:t>L. </a:t>
            </a:r>
            <a:r>
              <a:rPr lang="en-US" altLang="ja-JP" sz="1200" i="1" dirty="0" err="1"/>
              <a:t>paradoxa</a:t>
            </a:r>
            <a:r>
              <a:rPr lang="en-US" altLang="ja-JP" sz="1200" i="1" dirty="0"/>
              <a:t> </a:t>
            </a:r>
            <a:r>
              <a:rPr lang="en-US" altLang="ja-JP" sz="1200" dirty="0"/>
              <a:t>#1 and #3 analyzed by </a:t>
            </a:r>
            <a:r>
              <a:rPr lang="en-US" altLang="ja-JP" sz="1200" i="1" dirty="0"/>
              <a:t>in situ </a:t>
            </a:r>
            <a:r>
              <a:rPr lang="en-US" altLang="ja-JP" sz="1200" dirty="0"/>
              <a:t>hybridization with mixed probes for </a:t>
            </a:r>
            <a:r>
              <a:rPr lang="en-US" altLang="ja-JP" sz="1200" i="1" dirty="0"/>
              <a:t>V1Rs</a:t>
            </a:r>
            <a:r>
              <a:rPr lang="en-US" altLang="ja-JP" sz="1200" dirty="0"/>
              <a:t>.</a:t>
            </a:r>
          </a:p>
          <a:p>
            <a:r>
              <a:rPr lang="en-US" altLang="ja-JP" sz="1200" dirty="0"/>
              <a:t>Signals are detected in the basal to middle layer in the lamellar OE. Scale bars: 100 </a:t>
            </a:r>
            <a:r>
              <a:rPr lang="en-US" altLang="ja-JP" sz="1200" dirty="0">
                <a:latin typeface="Symbol" panose="05050102010706020507" pitchFamily="18" charset="2"/>
              </a:rPr>
              <a:t>m</a:t>
            </a:r>
            <a:r>
              <a:rPr lang="en-US" altLang="ja-JP" sz="1200" dirty="0"/>
              <a:t>m.</a:t>
            </a:r>
          </a:p>
        </p:txBody>
      </p:sp>
    </p:spTree>
    <p:extLst>
      <p:ext uri="{BB962C8B-B14F-4D97-AF65-F5344CB8AC3E}">
        <p14:creationId xmlns:p14="http://schemas.microsoft.com/office/powerpoint/2010/main" val="28947143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</TotalTime>
  <Words>54</Words>
  <Application>Microsoft Office PowerPoint</Application>
  <PresentationFormat>A4 210 x 297 mm</PresentationFormat>
  <Paragraphs>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Symbo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oko Nakamuta</dc:creator>
  <cp:lastModifiedBy>Nakamuta Nobuaki</cp:lastModifiedBy>
  <cp:revision>7</cp:revision>
  <dcterms:created xsi:type="dcterms:W3CDTF">2022-09-27T02:32:30Z</dcterms:created>
  <dcterms:modified xsi:type="dcterms:W3CDTF">2023-02-13T04:08:43Z</dcterms:modified>
</cp:coreProperties>
</file>